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9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2423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4837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865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3736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8153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934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3675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5568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9247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080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8618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1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9255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F744FB5-9D41-4021-BFC2-DBDDD51882C0}"/>
              </a:ext>
            </a:extLst>
          </p:cNvPr>
          <p:cNvSpPr txBox="1"/>
          <p:nvPr/>
        </p:nvSpPr>
        <p:spPr>
          <a:xfrm>
            <a:off x="178997" y="5754289"/>
            <a:ext cx="65000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TE2539 strain was derived from the recombination in the UL sub-region between the GA and J-1 early Asian strains.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2B2E9BA-BE2A-4DC1-BFAD-3BAB0F5AB7C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04634"/>
            <a:ext cx="6858000" cy="31812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4983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4</TotalTime>
  <Words>24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Kai Li</dc:creator>
  <cp:lastModifiedBy>likaihvri@163.com</cp:lastModifiedBy>
  <cp:revision>27</cp:revision>
  <dcterms:created xsi:type="dcterms:W3CDTF">2020-10-24T12:47:24Z</dcterms:created>
  <dcterms:modified xsi:type="dcterms:W3CDTF">2020-11-18T01:19:02Z</dcterms:modified>
</cp:coreProperties>
</file>